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CEF59AA-C1B2-784D-BC96-CD069AAC5DCB}" v="1" dt="2020-09-24T21:32:25.39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749"/>
    <p:restoredTop sz="96327"/>
  </p:normalViewPr>
  <p:slideViewPr>
    <p:cSldViewPr snapToGrid="0" snapToObjects="1" showGuides="1">
      <p:cViewPr varScale="1">
        <p:scale>
          <a:sx n="119" d="100"/>
          <a:sy n="119" d="100"/>
        </p:scale>
        <p:origin x="1128" y="1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PTIEUX Rae" userId="3a961199-96dc-4b2e-8ea9-3b6407fb953a" providerId="ADAL" clId="{1CEF59AA-C1B2-784D-BC96-CD069AAC5DCB}"/>
    <pc:docChg chg="modSld">
      <pc:chgData name="CAPTIEUX Rae" userId="3a961199-96dc-4b2e-8ea9-3b6407fb953a" providerId="ADAL" clId="{1CEF59AA-C1B2-784D-BC96-CD069AAC5DCB}" dt="2020-09-24T21:32:28.378" v="6" actId="20577"/>
      <pc:docMkLst>
        <pc:docMk/>
      </pc:docMkLst>
      <pc:sldChg chg="modSp mod">
        <pc:chgData name="CAPTIEUX Rae" userId="3a961199-96dc-4b2e-8ea9-3b6407fb953a" providerId="ADAL" clId="{1CEF59AA-C1B2-784D-BC96-CD069AAC5DCB}" dt="2020-09-24T21:32:28.378" v="6" actId="20577"/>
        <pc:sldMkLst>
          <pc:docMk/>
          <pc:sldMk cId="2361739135" sldId="268"/>
        </pc:sldMkLst>
        <pc:spChg chg="mod">
          <ac:chgData name="CAPTIEUX Rae" userId="3a961199-96dc-4b2e-8ea9-3b6407fb953a" providerId="ADAL" clId="{1CEF59AA-C1B2-784D-BC96-CD069AAC5DCB}" dt="2020-09-24T21:32:28.378" v="6" actId="20577"/>
          <ac:spMkLst>
            <pc:docMk/>
            <pc:sldMk cId="2361739135" sldId="268"/>
            <ac:spMk id="3" creationId="{E41390C6-FF12-084D-A15A-E1B77EFC7365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F1FCC1-6EE6-684D-9952-4592ABBC2FE9}" type="datetimeFigureOut">
              <a:rPr lang="en-US" smtClean="0"/>
              <a:t>9/24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4F5421-11C0-BE45-B08D-FC3C1ED8B1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4871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/>
              <a:t>P [21] Drug element present</a:t>
            </a:r>
          </a:p>
          <a:p>
            <a:endParaRPr lang="en-GB"/>
          </a:p>
          <a:p>
            <a:r>
              <a:rPr lang="en-GB"/>
              <a:t>Drug element present [6] "AT5 years"</a:t>
            </a:r>
          </a:p>
          <a:p>
            <a:r>
              <a:rPr lang="en-GB"/>
              <a:t> "AT5 years" [2] HB&lt;48,FPG&lt;7</a:t>
            </a:r>
          </a:p>
          <a:p>
            <a:r>
              <a:rPr lang="en-GB"/>
              <a:t> "AT5 years" [2] HB&lt;48&amp;FPG&lt;7</a:t>
            </a:r>
          </a:p>
          <a:p>
            <a:r>
              <a:rPr lang="en-GB"/>
              <a:t>  "AT5 years" [2] HB&lt;42&amp;FPG&lt;5.6</a:t>
            </a:r>
          </a:p>
          <a:p>
            <a:endParaRPr lang="en-GB"/>
          </a:p>
          <a:p>
            <a:r>
              <a:rPr lang="en-GB"/>
              <a:t>:Drug element present  #5D6D7E</a:t>
            </a:r>
          </a:p>
          <a:p>
            <a:r>
              <a:rPr lang="en-GB"/>
              <a:t>:"AT5 years" #5D6D7E</a:t>
            </a:r>
          </a:p>
          <a:p>
            <a:r>
              <a:rPr lang="en-GB"/>
              <a:t>:HB&lt;48&amp;FPG&lt;7 #5D6D7E</a:t>
            </a:r>
          </a:p>
          <a:p>
            <a:r>
              <a:rPr lang="en-GB"/>
              <a:t>:HB&lt;48,FPG&lt;7 #5D6D7E</a:t>
            </a:r>
          </a:p>
          <a:p>
            <a:r>
              <a:rPr lang="en-GB"/>
              <a:t>:HB&lt;42&amp;FPG&lt;5.6 #5D6D7E</a:t>
            </a:r>
          </a:p>
          <a:p>
            <a:endParaRPr lang="en-GB"/>
          </a:p>
          <a:p>
            <a:endParaRPr lang="en-GB"/>
          </a:p>
          <a:p>
            <a:r>
              <a:rPr lang="en-GB"/>
              <a:t>Drug element present [15] "For 5 year"</a:t>
            </a:r>
          </a:p>
          <a:p>
            <a:endParaRPr lang="en-GB"/>
          </a:p>
          <a:p>
            <a:r>
              <a:rPr lang="en-GB"/>
              <a:t> "For 5 year" [1]FPG&lt;5.6/100</a:t>
            </a:r>
          </a:p>
          <a:p>
            <a:r>
              <a:rPr lang="en-GB"/>
              <a:t> "For 5 year" [1]HB&lt;48,FPG&lt;7</a:t>
            </a:r>
          </a:p>
          <a:p>
            <a:r>
              <a:rPr lang="en-GB"/>
              <a:t> "For 5 year" [1]HB&lt;48,FPG&lt;5.6</a:t>
            </a:r>
          </a:p>
          <a:p>
            <a:r>
              <a:rPr lang="en-GB"/>
              <a:t> "For 5 year" [1]HB&lt;48&amp;FPG&lt;5.6</a:t>
            </a:r>
          </a:p>
          <a:p>
            <a:endParaRPr lang="en-GB"/>
          </a:p>
          <a:p>
            <a:endParaRPr lang="en-GB"/>
          </a:p>
          <a:p>
            <a:r>
              <a:rPr lang="en-GB"/>
              <a:t>"For 5 year" [7]HB&lt;42</a:t>
            </a:r>
          </a:p>
          <a:p>
            <a:r>
              <a:rPr lang="en-GB"/>
              <a:t>"For 5 year" [1]HB&lt;42,FPG&lt;5.6</a:t>
            </a:r>
          </a:p>
          <a:p>
            <a:r>
              <a:rPr lang="en-GB"/>
              <a:t>"For 5 year" [2]HB&lt;42&amp;FPG&lt;5.6</a:t>
            </a:r>
          </a:p>
          <a:p>
            <a:endParaRPr lang="en-GB"/>
          </a:p>
          <a:p>
            <a:r>
              <a:rPr lang="en-GB"/>
              <a:t>"For 5 year" [1]HB&lt;39</a:t>
            </a:r>
          </a:p>
          <a:p>
            <a:endParaRPr lang="en-GB"/>
          </a:p>
          <a:p>
            <a:r>
              <a:rPr lang="en-GB"/>
              <a:t>:"For 5 year" #5D6D7E</a:t>
            </a:r>
          </a:p>
          <a:p>
            <a:r>
              <a:rPr lang="en-GB"/>
              <a:t>:FPG&lt;5.6/100 #5D6D7E</a:t>
            </a:r>
          </a:p>
          <a:p>
            <a:r>
              <a:rPr lang="en-GB"/>
              <a:t>:HB&lt;48,FPG&lt;7 #5D6D7E</a:t>
            </a:r>
          </a:p>
          <a:p>
            <a:r>
              <a:rPr lang="en-GB"/>
              <a:t>:HB&lt;48,FPG&lt;5.6 #5D6D7E</a:t>
            </a:r>
          </a:p>
          <a:p>
            <a:r>
              <a:rPr lang="en-GB"/>
              <a:t>:HB&lt;48&amp;FPG&lt;5.6 #5D6D7E</a:t>
            </a:r>
          </a:p>
          <a:p>
            <a:r>
              <a:rPr lang="en-GB"/>
              <a:t>:HB&lt;42 #5D6D7E</a:t>
            </a:r>
          </a:p>
          <a:p>
            <a:r>
              <a:rPr lang="en-GB"/>
              <a:t>:HB&lt;42,FPG&lt;5.6 #5D6D7E</a:t>
            </a:r>
          </a:p>
          <a:p>
            <a:r>
              <a:rPr lang="en-GB"/>
              <a:t>:HB&lt;42&amp;FPG&lt;5.6 #5D6D7E</a:t>
            </a:r>
          </a:p>
          <a:p>
            <a:r>
              <a:rPr lang="en-GB"/>
              <a:t>:HB&lt;39 #5D6D7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7F2FC4-DA11-A149-8DA6-A9037C1576BE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30604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B71EB0-A153-7845-918D-63EE233F411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BAA1199-ECCF-794F-B788-7B118390CED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84017F-2D67-7940-87BB-F3E67B84E9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7AB245-E958-AF4A-8771-36DE472503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1F8159-0DB0-6F46-A540-364E0ED0DA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5416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8F296C-0359-F940-8858-359C4F93CF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7CA3596-925B-3E41-9006-4F113CCC1D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B8D450-72C4-6049-AE21-A5ADE356CA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15A521-501C-E446-BC62-6AC0E2CDFE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8C7F82-B7A0-F34F-9FE3-A1E6332098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83089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E172C73-F359-0840-9EC0-404F3B2D2F5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526BBBC-5D13-B04F-8B0C-82AAF32181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02147A-3DE4-6A47-91CA-1E41350F49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0F8119-AE33-A241-9D92-2B3027A28B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DF7C97-4D99-FB4C-92C6-C0D3C6089F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16283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55A5AC-672F-4642-8662-7285C99D2A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5D8094-4684-2842-A93D-0B212E6D802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7C8053-5441-754A-9C65-CD2AB775DD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2387DD-F2B3-0440-8788-FD56321F9C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4921E4-3639-4947-96B6-0712984A42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42521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728924-E957-994B-8C78-3B0E7048EA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D109CB-3594-A54E-A34A-76018C888C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D7F986-5A61-8B4D-8D4F-069C81260C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87894D-9405-E545-B2BF-5ABD179AE8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4871DA-9CE5-BB4F-8325-1678BA1F3A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5277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45D345-0204-2F4C-9D88-1C84951427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C9492AF-542A-6A46-9ABC-DB5D53C8739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4E1AC9E-4545-6546-9A8C-7F4CA4EE9F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401E09-7817-8741-9E8F-C617AA36C9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3BF4BC-5CEF-D64E-9D57-787461016D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7E667AA-8379-4540-91AA-43F6653A44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3929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2B8941-1A83-3A4D-B4A7-9EB1F59B1F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AF4C62-9D87-5F43-B3C4-0A63819A73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B5E6EBA-77EC-4E45-8681-83804B238F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5A4F034-819B-5349-895D-CC1B85CFF60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5D84BBF-4DB3-0440-858E-D2D952AE9A1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F639079-22A0-EF4B-B999-21354FCE02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2BA785E-FD98-EA47-91EE-EEFD92375F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8A9AE3C-AF1C-8348-BE73-DC3ED0CB99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42553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89F673-A059-B34A-BA62-D6083790D3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5BBE93A-29D6-C444-81FF-02F1B985CE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4D3209C-2E6F-DE45-98A1-3DB3CF5CE8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3E90635-2AD0-DD48-9560-F25434C144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2394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76EBF65-8D31-4F4E-A328-DFC976FA28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3FECE7E-12B5-8942-AF0B-FB0C254B2B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53E4620-0605-5445-9CE2-036CB067F8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03843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525AF9-5494-0144-9036-47D1A30DF5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A7A4FA-F0C7-5345-BF47-739BFBF7C6C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DA44600-BCB1-724C-BA94-DB8C56B4A4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51C26D-61D7-9D43-908E-387E9EA00B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FACD2E3-BC60-0240-881C-B77655981E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B4D528-ED3C-E342-9B27-BB96E9BFF4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25505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A29AEA-27A5-8245-A8EB-25C9AF0E76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32172F6-7064-5543-8287-D040533EEF7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0BCB8F-1486-A642-9A64-71C9235907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892C211-46FF-EF4E-A5DF-361DA4C39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749704-3DF3-5C44-AF93-84F7D607F1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578A23-EB0C-6348-AF5B-CDEF1BE326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9971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7A4CA3D-6954-614C-9CCC-417E897E63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83812A-645A-934C-BFBE-11CCCFF2D7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EFFEDD-3BC2-2047-B528-4DACBE82558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DBA127-E216-C540-91A3-F10317F346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949627-11AC-D044-BD3E-3062F688B2B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08036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refrigerator&#10;&#10;Description automatically generated">
            <a:extLst>
              <a:ext uri="{FF2B5EF4-FFF2-40B4-BE49-F238E27FC236}">
                <a16:creationId xmlns:a16="http://schemas.microsoft.com/office/drawing/2014/main" id="{20B57F7D-1B89-724C-A79F-4451E4407EC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10797" y="280384"/>
            <a:ext cx="6211429" cy="6211429"/>
          </a:xfrm>
          <a:prstGeom prst="rect">
            <a:avLst/>
          </a:prstGeom>
        </p:spPr>
      </p:pic>
      <p:sp>
        <p:nvSpPr>
          <p:cNvPr id="49" name="TextBox 48">
            <a:extLst>
              <a:ext uri="{FF2B5EF4-FFF2-40B4-BE49-F238E27FC236}">
                <a16:creationId xmlns:a16="http://schemas.microsoft.com/office/drawing/2014/main" id="{E1AB686A-BCBB-E543-843E-F50002EC95C4}"/>
              </a:ext>
            </a:extLst>
          </p:cNvPr>
          <p:cNvSpPr txBox="1"/>
          <p:nvPr/>
        </p:nvSpPr>
        <p:spPr>
          <a:xfrm>
            <a:off x="3402241" y="2937833"/>
            <a:ext cx="19176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>
                <a:latin typeface="Times" pitchFamily="2" charset="0"/>
              </a:rPr>
              <a:t>absence of GLT specified: 21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CA4D4EAD-1682-A748-818B-4D427FB1B6BA}"/>
              </a:ext>
            </a:extLst>
          </p:cNvPr>
          <p:cNvGrpSpPr/>
          <p:nvPr/>
        </p:nvGrpSpPr>
        <p:grpSpPr>
          <a:xfrm>
            <a:off x="2164756" y="495680"/>
            <a:ext cx="9786773" cy="5853222"/>
            <a:chOff x="2218602" y="785998"/>
            <a:chExt cx="9786773" cy="5578172"/>
          </a:xfrm>
        </p:grpSpPr>
        <p:grpSp>
          <p:nvGrpSpPr>
            <p:cNvPr id="2" name="Group 1"/>
            <p:cNvGrpSpPr/>
            <p:nvPr/>
          </p:nvGrpSpPr>
          <p:grpSpPr>
            <a:xfrm>
              <a:off x="2218602" y="785998"/>
              <a:ext cx="9786773" cy="4178109"/>
              <a:chOff x="2218602" y="800746"/>
              <a:chExt cx="9786773" cy="4178109"/>
            </a:xfrm>
          </p:grpSpPr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035B4858-BD3F-874C-9583-6B22F959DC17}"/>
                  </a:ext>
                </a:extLst>
              </p:cNvPr>
              <p:cNvSpPr txBox="1"/>
              <p:nvPr/>
            </p:nvSpPr>
            <p:spPr>
              <a:xfrm>
                <a:off x="2218602" y="2886155"/>
                <a:ext cx="1111766" cy="43997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>
                    <a:latin typeface="Times" pitchFamily="2" charset="0"/>
                  </a:rPr>
                  <a:t>21 </a:t>
                </a:r>
              </a:p>
              <a:p>
                <a:pPr algn="ctr"/>
                <a:r>
                  <a:rPr lang="en-GB" sz="800">
                    <a:latin typeface="Times" pitchFamily="2" charset="0"/>
                  </a:rPr>
                  <a:t>Prolonged Remission </a:t>
                </a:r>
              </a:p>
              <a:p>
                <a:pPr algn="ctr"/>
                <a:r>
                  <a:rPr lang="en-GB" sz="800">
                    <a:latin typeface="Times" pitchFamily="2" charset="0"/>
                  </a:rPr>
                  <a:t>definitions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7EBF3A03-2720-8749-B6AB-409BEA5200F0}"/>
                  </a:ext>
                </a:extLst>
              </p:cNvPr>
              <p:cNvSpPr txBox="1"/>
              <p:nvPr/>
            </p:nvSpPr>
            <p:spPr>
              <a:xfrm>
                <a:off x="9235865" y="3067493"/>
                <a:ext cx="2600325" cy="2053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>
                    <a:latin typeface="Times" pitchFamily="2" charset="0"/>
                  </a:rPr>
                  <a:t>FPG &lt;5.6mmol/l :1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F95F5731-5AC9-D346-BE55-8EB04D875FFC}"/>
                  </a:ext>
                </a:extLst>
              </p:cNvPr>
              <p:cNvSpPr txBox="1"/>
              <p:nvPr/>
            </p:nvSpPr>
            <p:spPr>
              <a:xfrm>
                <a:off x="9264167" y="800746"/>
                <a:ext cx="2741208" cy="2053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>
                    <a:latin typeface="Times" pitchFamily="2" charset="0"/>
                  </a:rPr>
                  <a:t>HbA1c &lt;48mmol/mol &amp; FPG &lt;7.0mmol/l: 2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0ABE94DA-9E15-C54B-96B8-C091E55AADA7}"/>
                  </a:ext>
                </a:extLst>
              </p:cNvPr>
              <p:cNvSpPr txBox="1"/>
              <p:nvPr/>
            </p:nvSpPr>
            <p:spPr>
              <a:xfrm>
                <a:off x="9249678" y="3824462"/>
                <a:ext cx="2741209" cy="2053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>
                    <a:latin typeface="Times" pitchFamily="2" charset="0"/>
                  </a:rPr>
                  <a:t>HbA1c &lt;48mmol/mol &amp; FPG &lt;5.6mmol/l: 1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64DDEC11-384B-864B-9CB1-607821417D97}"/>
                  </a:ext>
                </a:extLst>
              </p:cNvPr>
              <p:cNvSpPr txBox="1"/>
              <p:nvPr/>
            </p:nvSpPr>
            <p:spPr>
              <a:xfrm>
                <a:off x="9249678" y="4773535"/>
                <a:ext cx="2600325" cy="2053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>
                    <a:latin typeface="Times" pitchFamily="2" charset="0"/>
                  </a:rPr>
                  <a:t>HbA1c &lt;42mmol/mol: 7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25048373-0A07-3F40-BA46-80097895B380}"/>
                  </a:ext>
                </a:extLst>
              </p:cNvPr>
              <p:cNvSpPr txBox="1"/>
              <p:nvPr/>
            </p:nvSpPr>
            <p:spPr>
              <a:xfrm>
                <a:off x="5660515" y="3824462"/>
                <a:ext cx="1564207" cy="2053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GB" sz="800">
                    <a:latin typeface="Times" pitchFamily="2" charset="0"/>
                  </a:rPr>
                  <a:t>for 5 years: 15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1C6310A1-387B-0B40-BCF4-860443AEA259}"/>
                  </a:ext>
                </a:extLst>
              </p:cNvPr>
              <p:cNvSpPr txBox="1"/>
              <p:nvPr/>
            </p:nvSpPr>
            <p:spPr>
              <a:xfrm>
                <a:off x="6270357" y="1744342"/>
                <a:ext cx="949743" cy="2053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GB" sz="800">
                    <a:latin typeface="Times" pitchFamily="2" charset="0"/>
                  </a:rPr>
                  <a:t>at 5 years: 6</a:t>
                </a:r>
              </a:p>
            </p:txBody>
          </p:sp>
        </p:grp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64DDEC11-384B-864B-9CB1-607821417D97}"/>
                </a:ext>
              </a:extLst>
            </p:cNvPr>
            <p:cNvSpPr txBox="1"/>
            <p:nvPr/>
          </p:nvSpPr>
          <p:spPr>
            <a:xfrm>
              <a:off x="9264167" y="2364213"/>
              <a:ext cx="2727726" cy="2053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>
                  <a:latin typeface="Times" pitchFamily="2" charset="0"/>
                </a:rPr>
                <a:t>HbA1c &lt;42mmol/mol &amp; FPG&lt;5.6mmol/l: 4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BAC796D6-15B8-2E41-BD66-7A8E2788D5FD}"/>
                </a:ext>
              </a:extLst>
            </p:cNvPr>
            <p:cNvSpPr txBox="1"/>
            <p:nvPr/>
          </p:nvSpPr>
          <p:spPr>
            <a:xfrm>
              <a:off x="9235863" y="6158850"/>
              <a:ext cx="2600325" cy="2053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>
                  <a:latin typeface="Times" pitchFamily="2" charset="0"/>
                </a:rPr>
                <a:t>HbA1c&lt;39mmol/mol: 1</a:t>
              </a:r>
            </a:p>
          </p:txBody>
        </p:sp>
      </p:grp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F0A43569-F8AC-1B4B-825C-4A70F62A8717}"/>
              </a:ext>
            </a:extLst>
          </p:cNvPr>
          <p:cNvCxnSpPr>
            <a:cxnSpLocks/>
          </p:cNvCxnSpPr>
          <p:nvPr/>
        </p:nvCxnSpPr>
        <p:spPr>
          <a:xfrm>
            <a:off x="3293169" y="5605575"/>
            <a:ext cx="1347" cy="972041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6CB19C0E-E515-8943-9DA5-1A6604505B29}"/>
              </a:ext>
            </a:extLst>
          </p:cNvPr>
          <p:cNvCxnSpPr>
            <a:cxnSpLocks/>
          </p:cNvCxnSpPr>
          <p:nvPr/>
        </p:nvCxnSpPr>
        <p:spPr>
          <a:xfrm>
            <a:off x="5232400" y="5632066"/>
            <a:ext cx="0" cy="1002373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293478EC-C74F-4642-825B-2A6D412DF1D2}"/>
              </a:ext>
            </a:extLst>
          </p:cNvPr>
          <p:cNvCxnSpPr>
            <a:cxnSpLocks/>
          </p:cNvCxnSpPr>
          <p:nvPr/>
        </p:nvCxnSpPr>
        <p:spPr>
          <a:xfrm>
            <a:off x="7174144" y="5659921"/>
            <a:ext cx="1356" cy="917695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3BFD8177-DF6D-474C-B8CA-732265E55776}"/>
              </a:ext>
            </a:extLst>
          </p:cNvPr>
          <p:cNvSpPr txBox="1"/>
          <p:nvPr/>
        </p:nvSpPr>
        <p:spPr>
          <a:xfrm>
            <a:off x="3305931" y="6276382"/>
            <a:ext cx="16130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>
                <a:latin typeface="Times" pitchFamily="2" charset="0"/>
                <a:cs typeface="Times New Roman" panose="02020603050405020304" pitchFamily="18" charset="0"/>
              </a:rPr>
              <a:t>GLT component</a:t>
            </a:r>
          </a:p>
          <a:p>
            <a:r>
              <a:rPr lang="en-GB" sz="800">
                <a:latin typeface="Times" pitchFamily="2" charset="0"/>
                <a:cs typeface="Times New Roman" panose="02020603050405020304" pitchFamily="18" charset="0"/>
              </a:rPr>
              <a:t>Reported 1 way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C5C50C1-36E8-4947-84A0-8FF85E49214A}"/>
              </a:ext>
            </a:extLst>
          </p:cNvPr>
          <p:cNvSpPr txBox="1"/>
          <p:nvPr/>
        </p:nvSpPr>
        <p:spPr>
          <a:xfrm>
            <a:off x="5247675" y="6295429"/>
            <a:ext cx="16130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>
                <a:latin typeface="Times" pitchFamily="2" charset="0"/>
                <a:cs typeface="Times New Roman" panose="02020603050405020304" pitchFamily="18" charset="0"/>
              </a:rPr>
              <a:t>Time component</a:t>
            </a:r>
          </a:p>
          <a:p>
            <a:r>
              <a:rPr lang="en-GB" sz="800">
                <a:latin typeface="Times" pitchFamily="2" charset="0"/>
                <a:cs typeface="Times New Roman" panose="02020603050405020304" pitchFamily="18" charset="0"/>
              </a:rPr>
              <a:t>Reported 2 ways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1CF79A5-71F9-0F4C-8188-D98AEA92DBBE}"/>
              </a:ext>
            </a:extLst>
          </p:cNvPr>
          <p:cNvSpPr txBox="1"/>
          <p:nvPr/>
        </p:nvSpPr>
        <p:spPr>
          <a:xfrm>
            <a:off x="7219172" y="6276382"/>
            <a:ext cx="16130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>
                <a:latin typeface="Times" pitchFamily="2" charset="0"/>
                <a:cs typeface="Times New Roman" panose="02020603050405020304" pitchFamily="18" charset="0"/>
              </a:rPr>
              <a:t>Glycaemic component</a:t>
            </a:r>
          </a:p>
          <a:p>
            <a:r>
              <a:rPr lang="en-GB" sz="800">
                <a:latin typeface="Times" pitchFamily="2" charset="0"/>
                <a:cs typeface="Times New Roman" panose="02020603050405020304" pitchFamily="18" charset="0"/>
              </a:rPr>
              <a:t>Reported 9 way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F7BDCA9-4380-6142-83FD-DCA878369C92}"/>
              </a:ext>
            </a:extLst>
          </p:cNvPr>
          <p:cNvSpPr txBox="1"/>
          <p:nvPr/>
        </p:nvSpPr>
        <p:spPr>
          <a:xfrm>
            <a:off x="9210321" y="1194130"/>
            <a:ext cx="26003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>
                <a:latin typeface="Times" pitchFamily="2" charset="0"/>
              </a:rPr>
              <a:t>HbA1c &lt;48mmol/mol, FPG &lt;7.0mmol/l: 3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AE69A5A-5807-6641-A595-0CA0ED54F91B}"/>
              </a:ext>
            </a:extLst>
          </p:cNvPr>
          <p:cNvSpPr txBox="1"/>
          <p:nvPr/>
        </p:nvSpPr>
        <p:spPr>
          <a:xfrm>
            <a:off x="9182018" y="3268897"/>
            <a:ext cx="26003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>
                <a:latin typeface="Times" pitchFamily="2" charset="0"/>
              </a:rPr>
              <a:t>HbA1c &lt;48mmol/mol,FPG &lt;5.6mmol/l: 1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7D1DBF6-BFFC-6C4C-B99A-32FA27E95D72}"/>
              </a:ext>
            </a:extLst>
          </p:cNvPr>
          <p:cNvSpPr txBox="1"/>
          <p:nvPr/>
        </p:nvSpPr>
        <p:spPr>
          <a:xfrm>
            <a:off x="9182017" y="5720264"/>
            <a:ext cx="26003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>
                <a:latin typeface="Times" pitchFamily="2" charset="0"/>
              </a:rPr>
              <a:t>HbA1c &lt;42mmol/mol, FPG&lt;5.6mmol/l: 1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E41390C6-FF12-084D-A15A-E1B77EFC7365}"/>
              </a:ext>
            </a:extLst>
          </p:cNvPr>
          <p:cNvSpPr/>
          <p:nvPr/>
        </p:nvSpPr>
        <p:spPr>
          <a:xfrm>
            <a:off x="0" y="12186"/>
            <a:ext cx="12192000" cy="28020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1000"/>
              </a:spcAft>
            </a:pPr>
            <a:r>
              <a:rPr lang="en-GB" sz="1200" b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4 Fig: Sankey </a:t>
            </a: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iagram to illustrate heterogeneity for each component of the remission definition: glucose lowering therapy, time and glycaemic </a:t>
            </a:r>
            <a:r>
              <a:rPr lang="en-GB" sz="1200" b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omponent for </a:t>
            </a: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rolonged Remission</a:t>
            </a:r>
            <a:endParaRPr lang="en-GB" sz="11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2AC6B0F2-2D12-F148-A40F-1F1E9460E04F}"/>
              </a:ext>
            </a:extLst>
          </p:cNvPr>
          <p:cNvSpPr/>
          <p:nvPr/>
        </p:nvSpPr>
        <p:spPr>
          <a:xfrm>
            <a:off x="0" y="534270"/>
            <a:ext cx="4530398" cy="2566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05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d indicates missing or ambiguous within each component only</a:t>
            </a:r>
            <a:endParaRPr lang="en-GB" sz="1050" b="1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617391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473</Words>
  <Application>Microsoft Macintosh PowerPoint</Application>
  <PresentationFormat>Widescreen</PresentationFormat>
  <Paragraphs>6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PTIEUX Rae</dc:creator>
  <cp:lastModifiedBy>CAPTIEUX Rae</cp:lastModifiedBy>
  <cp:revision>7</cp:revision>
  <dcterms:created xsi:type="dcterms:W3CDTF">2020-09-01T19:34:41Z</dcterms:created>
  <dcterms:modified xsi:type="dcterms:W3CDTF">2020-09-24T21:32:29Z</dcterms:modified>
</cp:coreProperties>
</file>